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BBCDA-51EC-4303-840C-FC96BE4BC1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EEF4D-D684-493D-A710-EC01193E4C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DD300-8753-44FD-9218-90752D6F3F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2E980-793B-4716-BB27-5162FC3AA9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F39C3-45A7-47E9-B8E3-BF85744134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0FCD8F-F88B-42F0-BCCA-CA6E03E3AC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5C7E0-0FE9-4B18-ABEB-23A06F2669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5ACAD-8679-4733-9AAB-715B6CB942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760F4-405E-46CB-BA8E-CAD1D8EA0C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06411F-F921-4DD2-A0FB-807F28F89F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7CA1A-1094-4EB1-93E1-077DC345CA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9C0F2-7D04-43D0-9714-BE98817DAB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0E4E2D-1F49-4A58-9E0D-AD3206163FB2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1"/>
          <p:cNvGrpSpPr/>
          <p:nvPr/>
        </p:nvGrpSpPr>
        <p:grpSpPr>
          <a:xfrm>
            <a:off x="1475640" y="549360"/>
            <a:ext cx="2016720" cy="1512720"/>
            <a:chOff x="1475640" y="549360"/>
            <a:chExt cx="2016720" cy="1512720"/>
          </a:xfrm>
        </p:grpSpPr>
        <p:sp>
          <p:nvSpPr>
            <p:cNvPr id="42" name="Rectangle 5"/>
            <p:cNvSpPr/>
            <p:nvPr/>
          </p:nvSpPr>
          <p:spPr>
            <a:xfrm>
              <a:off x="1475640" y="1413000"/>
              <a:ext cx="592200" cy="335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100" spc="-1" strike="noStrike">
                  <a:solidFill>
                    <a:srgbClr val="000000"/>
                  </a:solidFill>
                  <a:latin typeface="Arial"/>
                </a:rPr>
                <a:t>P-AMPK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100" spc="-1" strike="noStrike">
                  <a:solidFill>
                    <a:srgbClr val="000000"/>
                  </a:solidFill>
                  <a:latin typeface="Arial"/>
                </a:rPr>
                <a:t>(Thr172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8"/>
            <p:cNvSpPr/>
            <p:nvPr/>
          </p:nvSpPr>
          <p:spPr>
            <a:xfrm>
              <a:off x="1506240" y="1082520"/>
              <a:ext cx="498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CA" sz="1100" spc="-1" strike="noStrike">
                  <a:solidFill>
                    <a:srgbClr val="000000"/>
                  </a:solidFill>
                  <a:latin typeface="Arial"/>
                </a:rPr>
                <a:t>AMPK</a:t>
              </a:r>
              <a:r>
                <a:rPr b="1" lang="el-GR" sz="1100" spc="-1" strike="noStrike">
                  <a:solidFill>
                    <a:srgbClr val="000000"/>
                  </a:solidFill>
                  <a:latin typeface="Arial"/>
                </a:rPr>
                <a:t>α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9"/>
            <p:cNvSpPr/>
            <p:nvPr/>
          </p:nvSpPr>
          <p:spPr>
            <a:xfrm>
              <a:off x="2340000" y="549360"/>
              <a:ext cx="419040" cy="390240"/>
            </a:xfrm>
            <a:custGeom>
              <a:avLst/>
              <a:gdLst>
                <a:gd name="textAreaLeft" fmla="*/ 0 w 419040"/>
                <a:gd name="textAreaRight" fmla="*/ 419400 w 419040"/>
                <a:gd name="textAreaTop" fmla="*/ 0 h 390240"/>
                <a:gd name="textAreaBottom" fmla="*/ 390600 h 390240"/>
              </a:gdLst>
              <a:ahLst/>
              <a:rect l="textAreaLeft" t="textAreaTop" r="textAreaRight" b="textAreaBottom"/>
              <a:pathLst>
                <a:path w="751" h="701">
                  <a:moveTo>
                    <a:pt x="137" y="599"/>
                  </a:moveTo>
                  <a:lnTo>
                    <a:pt x="171" y="583"/>
                  </a:lnTo>
                  <a:cubicBezTo>
                    <a:pt x="181" y="601"/>
                    <a:pt x="184" y="619"/>
                    <a:pt x="181" y="634"/>
                  </a:cubicBezTo>
                  <a:cubicBezTo>
                    <a:pt x="178" y="650"/>
                    <a:pt x="169" y="665"/>
                    <a:pt x="154" y="678"/>
                  </a:cubicBezTo>
                  <a:cubicBezTo>
                    <a:pt x="136" y="694"/>
                    <a:pt x="116" y="701"/>
                    <a:pt x="93" y="699"/>
                  </a:cubicBezTo>
                  <a:cubicBezTo>
                    <a:pt x="70" y="698"/>
                    <a:pt x="49" y="686"/>
                    <a:pt x="30" y="664"/>
                  </a:cubicBezTo>
                  <a:cubicBezTo>
                    <a:pt x="10" y="642"/>
                    <a:pt x="0" y="619"/>
                    <a:pt x="0" y="596"/>
                  </a:cubicBezTo>
                  <a:cubicBezTo>
                    <a:pt x="0" y="573"/>
                    <a:pt x="10" y="553"/>
                    <a:pt x="29" y="535"/>
                  </a:cubicBezTo>
                  <a:cubicBezTo>
                    <a:pt x="46" y="520"/>
                    <a:pt x="64" y="513"/>
                    <a:pt x="83" y="514"/>
                  </a:cubicBezTo>
                  <a:cubicBezTo>
                    <a:pt x="95" y="514"/>
                    <a:pt x="107" y="518"/>
                    <a:pt x="120" y="526"/>
                  </a:cubicBezTo>
                  <a:lnTo>
                    <a:pt x="98" y="557"/>
                  </a:lnTo>
                  <a:cubicBezTo>
                    <a:pt x="90" y="552"/>
                    <a:pt x="82" y="549"/>
                    <a:pt x="73" y="550"/>
                  </a:cubicBezTo>
                  <a:cubicBezTo>
                    <a:pt x="64" y="550"/>
                    <a:pt x="56" y="554"/>
                    <a:pt x="49" y="560"/>
                  </a:cubicBezTo>
                  <a:cubicBezTo>
                    <a:pt x="39" y="569"/>
                    <a:pt x="34" y="580"/>
                    <a:pt x="34" y="593"/>
                  </a:cubicBezTo>
                  <a:cubicBezTo>
                    <a:pt x="35" y="606"/>
                    <a:pt x="42" y="621"/>
                    <a:pt x="57" y="637"/>
                  </a:cubicBezTo>
                  <a:cubicBezTo>
                    <a:pt x="72" y="654"/>
                    <a:pt x="86" y="664"/>
                    <a:pt x="99" y="665"/>
                  </a:cubicBezTo>
                  <a:cubicBezTo>
                    <a:pt x="112" y="667"/>
                    <a:pt x="123" y="664"/>
                    <a:pt x="133" y="655"/>
                  </a:cubicBezTo>
                  <a:cubicBezTo>
                    <a:pt x="140" y="648"/>
                    <a:pt x="144" y="640"/>
                    <a:pt x="146" y="631"/>
                  </a:cubicBezTo>
                  <a:cubicBezTo>
                    <a:pt x="147" y="621"/>
                    <a:pt x="144" y="611"/>
                    <a:pt x="137" y="599"/>
                  </a:cubicBezTo>
                  <a:close/>
                  <a:moveTo>
                    <a:pt x="186" y="553"/>
                  </a:moveTo>
                  <a:cubicBezTo>
                    <a:pt x="178" y="545"/>
                    <a:pt x="173" y="534"/>
                    <a:pt x="170" y="522"/>
                  </a:cubicBezTo>
                  <a:cubicBezTo>
                    <a:pt x="167" y="511"/>
                    <a:pt x="167" y="499"/>
                    <a:pt x="171" y="488"/>
                  </a:cubicBezTo>
                  <a:cubicBezTo>
                    <a:pt x="175" y="476"/>
                    <a:pt x="182" y="466"/>
                    <a:pt x="192" y="458"/>
                  </a:cubicBezTo>
                  <a:cubicBezTo>
                    <a:pt x="206" y="444"/>
                    <a:pt x="223" y="438"/>
                    <a:pt x="241" y="439"/>
                  </a:cubicBezTo>
                  <a:cubicBezTo>
                    <a:pt x="260" y="440"/>
                    <a:pt x="275" y="448"/>
                    <a:pt x="289" y="463"/>
                  </a:cubicBezTo>
                  <a:cubicBezTo>
                    <a:pt x="302" y="478"/>
                    <a:pt x="308" y="495"/>
                    <a:pt x="308" y="513"/>
                  </a:cubicBezTo>
                  <a:cubicBezTo>
                    <a:pt x="307" y="531"/>
                    <a:pt x="299" y="547"/>
                    <a:pt x="285" y="560"/>
                  </a:cubicBezTo>
                  <a:cubicBezTo>
                    <a:pt x="276" y="569"/>
                    <a:pt x="265" y="574"/>
                    <a:pt x="253" y="578"/>
                  </a:cubicBezTo>
                  <a:cubicBezTo>
                    <a:pt x="241" y="581"/>
                    <a:pt x="230" y="581"/>
                    <a:pt x="218" y="577"/>
                  </a:cubicBezTo>
                  <a:cubicBezTo>
                    <a:pt x="207" y="572"/>
                    <a:pt x="196" y="565"/>
                    <a:pt x="186" y="553"/>
                  </a:cubicBezTo>
                  <a:close/>
                  <a:moveTo>
                    <a:pt x="214" y="531"/>
                  </a:moveTo>
                  <a:cubicBezTo>
                    <a:pt x="223" y="541"/>
                    <a:pt x="232" y="546"/>
                    <a:pt x="241" y="547"/>
                  </a:cubicBezTo>
                  <a:cubicBezTo>
                    <a:pt x="250" y="548"/>
                    <a:pt x="259" y="545"/>
                    <a:pt x="265" y="539"/>
                  </a:cubicBezTo>
                  <a:cubicBezTo>
                    <a:pt x="272" y="533"/>
                    <a:pt x="276" y="525"/>
                    <a:pt x="275" y="516"/>
                  </a:cubicBezTo>
                  <a:cubicBezTo>
                    <a:pt x="275" y="507"/>
                    <a:pt x="271" y="497"/>
                    <a:pt x="262" y="487"/>
                  </a:cubicBezTo>
                  <a:cubicBezTo>
                    <a:pt x="253" y="477"/>
                    <a:pt x="244" y="472"/>
                    <a:pt x="235" y="471"/>
                  </a:cubicBezTo>
                  <a:cubicBezTo>
                    <a:pt x="226" y="470"/>
                    <a:pt x="218" y="473"/>
                    <a:pt x="211" y="479"/>
                  </a:cubicBezTo>
                  <a:cubicBezTo>
                    <a:pt x="204" y="485"/>
                    <a:pt x="201" y="493"/>
                    <a:pt x="201" y="502"/>
                  </a:cubicBezTo>
                  <a:cubicBezTo>
                    <a:pt x="201" y="511"/>
                    <a:pt x="205" y="521"/>
                    <a:pt x="214" y="531"/>
                  </a:cubicBezTo>
                  <a:close/>
                  <a:moveTo>
                    <a:pt x="446" y="411"/>
                  </a:moveTo>
                  <a:lnTo>
                    <a:pt x="420" y="434"/>
                  </a:lnTo>
                  <a:lnTo>
                    <a:pt x="375" y="384"/>
                  </a:lnTo>
                  <a:cubicBezTo>
                    <a:pt x="365" y="373"/>
                    <a:pt x="358" y="367"/>
                    <a:pt x="355" y="365"/>
                  </a:cubicBezTo>
                  <a:cubicBezTo>
                    <a:pt x="351" y="363"/>
                    <a:pt x="347" y="362"/>
                    <a:pt x="343" y="362"/>
                  </a:cubicBezTo>
                  <a:cubicBezTo>
                    <a:pt x="338" y="363"/>
                    <a:pt x="335" y="365"/>
                    <a:pt x="331" y="368"/>
                  </a:cubicBezTo>
                  <a:cubicBezTo>
                    <a:pt x="327" y="372"/>
                    <a:pt x="324" y="377"/>
                    <a:pt x="322" y="383"/>
                  </a:cubicBezTo>
                  <a:cubicBezTo>
                    <a:pt x="321" y="388"/>
                    <a:pt x="321" y="394"/>
                    <a:pt x="324" y="399"/>
                  </a:cubicBezTo>
                  <a:cubicBezTo>
                    <a:pt x="326" y="404"/>
                    <a:pt x="332" y="413"/>
                    <a:pt x="342" y="424"/>
                  </a:cubicBezTo>
                  <a:lnTo>
                    <a:pt x="382" y="468"/>
                  </a:lnTo>
                  <a:lnTo>
                    <a:pt x="356" y="492"/>
                  </a:lnTo>
                  <a:lnTo>
                    <a:pt x="267" y="393"/>
                  </a:lnTo>
                  <a:lnTo>
                    <a:pt x="292" y="371"/>
                  </a:lnTo>
                  <a:lnTo>
                    <a:pt x="305" y="386"/>
                  </a:lnTo>
                  <a:cubicBezTo>
                    <a:pt x="303" y="367"/>
                    <a:pt x="309" y="352"/>
                    <a:pt x="322" y="340"/>
                  </a:cubicBezTo>
                  <a:cubicBezTo>
                    <a:pt x="328" y="335"/>
                    <a:pt x="334" y="331"/>
                    <a:pt x="341" y="329"/>
                  </a:cubicBezTo>
                  <a:cubicBezTo>
                    <a:pt x="347" y="327"/>
                    <a:pt x="353" y="326"/>
                    <a:pt x="359" y="327"/>
                  </a:cubicBezTo>
                  <a:cubicBezTo>
                    <a:pt x="364" y="328"/>
                    <a:pt x="369" y="330"/>
                    <a:pt x="374" y="333"/>
                  </a:cubicBezTo>
                  <a:cubicBezTo>
                    <a:pt x="378" y="337"/>
                    <a:pt x="384" y="342"/>
                    <a:pt x="391" y="350"/>
                  </a:cubicBezTo>
                  <a:lnTo>
                    <a:pt x="446" y="411"/>
                  </a:lnTo>
                  <a:close/>
                  <a:moveTo>
                    <a:pt x="432" y="245"/>
                  </a:moveTo>
                  <a:lnTo>
                    <a:pt x="451" y="266"/>
                  </a:lnTo>
                  <a:lnTo>
                    <a:pt x="433" y="282"/>
                  </a:lnTo>
                  <a:lnTo>
                    <a:pt x="469" y="322"/>
                  </a:lnTo>
                  <a:cubicBezTo>
                    <a:pt x="476" y="330"/>
                    <a:pt x="480" y="334"/>
                    <a:pt x="482" y="335"/>
                  </a:cubicBezTo>
                  <a:cubicBezTo>
                    <a:pt x="483" y="336"/>
                    <a:pt x="485" y="337"/>
                    <a:pt x="487" y="337"/>
                  </a:cubicBezTo>
                  <a:cubicBezTo>
                    <a:pt x="489" y="336"/>
                    <a:pt x="491" y="336"/>
                    <a:pt x="493" y="334"/>
                  </a:cubicBezTo>
                  <a:cubicBezTo>
                    <a:pt x="495" y="332"/>
                    <a:pt x="498" y="328"/>
                    <a:pt x="501" y="322"/>
                  </a:cubicBezTo>
                  <a:lnTo>
                    <a:pt x="521" y="340"/>
                  </a:lnTo>
                  <a:cubicBezTo>
                    <a:pt x="518" y="348"/>
                    <a:pt x="512" y="356"/>
                    <a:pt x="504" y="363"/>
                  </a:cubicBezTo>
                  <a:cubicBezTo>
                    <a:pt x="499" y="367"/>
                    <a:pt x="495" y="370"/>
                    <a:pt x="489" y="372"/>
                  </a:cubicBezTo>
                  <a:cubicBezTo>
                    <a:pt x="484" y="374"/>
                    <a:pt x="480" y="374"/>
                    <a:pt x="475" y="373"/>
                  </a:cubicBezTo>
                  <a:cubicBezTo>
                    <a:pt x="471" y="372"/>
                    <a:pt x="467" y="370"/>
                    <a:pt x="463" y="366"/>
                  </a:cubicBezTo>
                  <a:cubicBezTo>
                    <a:pt x="459" y="364"/>
                    <a:pt x="454" y="358"/>
                    <a:pt x="445" y="349"/>
                  </a:cubicBezTo>
                  <a:lnTo>
                    <a:pt x="407" y="306"/>
                  </a:lnTo>
                  <a:lnTo>
                    <a:pt x="395" y="316"/>
                  </a:lnTo>
                  <a:lnTo>
                    <a:pt x="376" y="296"/>
                  </a:lnTo>
                  <a:lnTo>
                    <a:pt x="388" y="285"/>
                  </a:lnTo>
                  <a:lnTo>
                    <a:pt x="370" y="265"/>
                  </a:lnTo>
                  <a:lnTo>
                    <a:pt x="383" y="226"/>
                  </a:lnTo>
                  <a:lnTo>
                    <a:pt x="414" y="261"/>
                  </a:lnTo>
                  <a:lnTo>
                    <a:pt x="432" y="245"/>
                  </a:lnTo>
                  <a:close/>
                  <a:moveTo>
                    <a:pt x="560" y="309"/>
                  </a:moveTo>
                  <a:lnTo>
                    <a:pt x="534" y="332"/>
                  </a:lnTo>
                  <a:lnTo>
                    <a:pt x="445" y="233"/>
                  </a:lnTo>
                  <a:lnTo>
                    <a:pt x="469" y="212"/>
                  </a:lnTo>
                  <a:lnTo>
                    <a:pt x="482" y="226"/>
                  </a:lnTo>
                  <a:cubicBezTo>
                    <a:pt x="480" y="215"/>
                    <a:pt x="480" y="208"/>
                    <a:pt x="481" y="202"/>
                  </a:cubicBezTo>
                  <a:cubicBezTo>
                    <a:pt x="483" y="197"/>
                    <a:pt x="485" y="193"/>
                    <a:pt x="490" y="189"/>
                  </a:cubicBezTo>
                  <a:cubicBezTo>
                    <a:pt x="496" y="184"/>
                    <a:pt x="503" y="180"/>
                    <a:pt x="511" y="179"/>
                  </a:cubicBezTo>
                  <a:lnTo>
                    <a:pt x="524" y="209"/>
                  </a:lnTo>
                  <a:cubicBezTo>
                    <a:pt x="517" y="210"/>
                    <a:pt x="511" y="212"/>
                    <a:pt x="508" y="215"/>
                  </a:cubicBezTo>
                  <a:cubicBezTo>
                    <a:pt x="504" y="219"/>
                    <a:pt x="502" y="222"/>
                    <a:pt x="501" y="227"/>
                  </a:cubicBezTo>
                  <a:cubicBezTo>
                    <a:pt x="500" y="231"/>
                    <a:pt x="502" y="236"/>
                    <a:pt x="505" y="243"/>
                  </a:cubicBezTo>
                  <a:cubicBezTo>
                    <a:pt x="508" y="250"/>
                    <a:pt x="517" y="261"/>
                    <a:pt x="532" y="278"/>
                  </a:cubicBezTo>
                  <a:lnTo>
                    <a:pt x="560" y="309"/>
                  </a:lnTo>
                  <a:close/>
                  <a:moveTo>
                    <a:pt x="555" y="222"/>
                  </a:moveTo>
                  <a:cubicBezTo>
                    <a:pt x="547" y="213"/>
                    <a:pt x="541" y="203"/>
                    <a:pt x="538" y="191"/>
                  </a:cubicBezTo>
                  <a:cubicBezTo>
                    <a:pt x="535" y="179"/>
                    <a:pt x="536" y="167"/>
                    <a:pt x="540" y="156"/>
                  </a:cubicBezTo>
                  <a:cubicBezTo>
                    <a:pt x="544" y="144"/>
                    <a:pt x="550" y="134"/>
                    <a:pt x="560" y="126"/>
                  </a:cubicBezTo>
                  <a:cubicBezTo>
                    <a:pt x="575" y="112"/>
                    <a:pt x="592" y="106"/>
                    <a:pt x="610" y="107"/>
                  </a:cubicBezTo>
                  <a:cubicBezTo>
                    <a:pt x="628" y="108"/>
                    <a:pt x="644" y="116"/>
                    <a:pt x="657" y="131"/>
                  </a:cubicBezTo>
                  <a:cubicBezTo>
                    <a:pt x="671" y="146"/>
                    <a:pt x="677" y="163"/>
                    <a:pt x="676" y="181"/>
                  </a:cubicBezTo>
                  <a:cubicBezTo>
                    <a:pt x="675" y="200"/>
                    <a:pt x="668" y="215"/>
                    <a:pt x="653" y="229"/>
                  </a:cubicBezTo>
                  <a:cubicBezTo>
                    <a:pt x="644" y="237"/>
                    <a:pt x="634" y="242"/>
                    <a:pt x="622" y="246"/>
                  </a:cubicBezTo>
                  <a:cubicBezTo>
                    <a:pt x="610" y="249"/>
                    <a:pt x="598" y="249"/>
                    <a:pt x="587" y="245"/>
                  </a:cubicBezTo>
                  <a:cubicBezTo>
                    <a:pt x="575" y="241"/>
                    <a:pt x="565" y="233"/>
                    <a:pt x="555" y="222"/>
                  </a:cubicBezTo>
                  <a:close/>
                  <a:moveTo>
                    <a:pt x="583" y="199"/>
                  </a:moveTo>
                  <a:cubicBezTo>
                    <a:pt x="591" y="209"/>
                    <a:pt x="600" y="214"/>
                    <a:pt x="610" y="215"/>
                  </a:cubicBezTo>
                  <a:cubicBezTo>
                    <a:pt x="619" y="216"/>
                    <a:pt x="627" y="214"/>
                    <a:pt x="634" y="207"/>
                  </a:cubicBezTo>
                  <a:cubicBezTo>
                    <a:pt x="641" y="201"/>
                    <a:pt x="644" y="194"/>
                    <a:pt x="644" y="184"/>
                  </a:cubicBezTo>
                  <a:cubicBezTo>
                    <a:pt x="644" y="175"/>
                    <a:pt x="639" y="165"/>
                    <a:pt x="631" y="155"/>
                  </a:cubicBezTo>
                  <a:cubicBezTo>
                    <a:pt x="622" y="146"/>
                    <a:pt x="613" y="140"/>
                    <a:pt x="604" y="139"/>
                  </a:cubicBezTo>
                  <a:cubicBezTo>
                    <a:pt x="594" y="138"/>
                    <a:pt x="586" y="141"/>
                    <a:pt x="579" y="147"/>
                  </a:cubicBezTo>
                  <a:cubicBezTo>
                    <a:pt x="573" y="153"/>
                    <a:pt x="569" y="161"/>
                    <a:pt x="569" y="170"/>
                  </a:cubicBezTo>
                  <a:cubicBezTo>
                    <a:pt x="569" y="179"/>
                    <a:pt x="574" y="189"/>
                    <a:pt x="583" y="199"/>
                  </a:cubicBezTo>
                  <a:close/>
                  <a:moveTo>
                    <a:pt x="725" y="160"/>
                  </a:moveTo>
                  <a:lnTo>
                    <a:pt x="602" y="24"/>
                  </a:lnTo>
                  <a:lnTo>
                    <a:pt x="629" y="0"/>
                  </a:lnTo>
                  <a:lnTo>
                    <a:pt x="751" y="136"/>
                  </a:lnTo>
                  <a:lnTo>
                    <a:pt x="725" y="16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10"/>
            <p:cNvSpPr/>
            <p:nvPr/>
          </p:nvSpPr>
          <p:spPr>
            <a:xfrm>
              <a:off x="3059280" y="765000"/>
              <a:ext cx="163440" cy="142920"/>
            </a:xfrm>
            <a:custGeom>
              <a:avLst/>
              <a:gdLst>
                <a:gd name="textAreaLeft" fmla="*/ 0 w 163440"/>
                <a:gd name="textAreaRight" fmla="*/ 163800 w 163440"/>
                <a:gd name="textAreaTop" fmla="*/ 0 h 142920"/>
                <a:gd name="textAreaBottom" fmla="*/ 143280 h 142920"/>
              </a:gdLst>
              <a:ahLst/>
              <a:rect l="textAreaLeft" t="textAreaTop" r="textAreaRight" b="textAreaBottom"/>
              <a:pathLst>
                <a:path w="294" h="257">
                  <a:moveTo>
                    <a:pt x="110" y="257"/>
                  </a:moveTo>
                  <a:lnTo>
                    <a:pt x="0" y="111"/>
                  </a:lnTo>
                  <a:lnTo>
                    <a:pt x="29" y="89"/>
                  </a:lnTo>
                  <a:lnTo>
                    <a:pt x="140" y="235"/>
                  </a:lnTo>
                  <a:lnTo>
                    <a:pt x="110" y="257"/>
                  </a:lnTo>
                  <a:close/>
                  <a:moveTo>
                    <a:pt x="162" y="218"/>
                  </a:moveTo>
                  <a:lnTo>
                    <a:pt x="52" y="72"/>
                  </a:lnTo>
                  <a:lnTo>
                    <a:pt x="114" y="25"/>
                  </a:lnTo>
                  <a:cubicBezTo>
                    <a:pt x="130" y="13"/>
                    <a:pt x="142" y="6"/>
                    <a:pt x="151" y="3"/>
                  </a:cubicBezTo>
                  <a:cubicBezTo>
                    <a:pt x="160" y="0"/>
                    <a:pt x="169" y="1"/>
                    <a:pt x="179" y="4"/>
                  </a:cubicBezTo>
                  <a:cubicBezTo>
                    <a:pt x="188" y="8"/>
                    <a:pt x="196" y="14"/>
                    <a:pt x="202" y="22"/>
                  </a:cubicBezTo>
                  <a:cubicBezTo>
                    <a:pt x="211" y="33"/>
                    <a:pt x="214" y="45"/>
                    <a:pt x="213" y="57"/>
                  </a:cubicBezTo>
                  <a:cubicBezTo>
                    <a:pt x="212" y="69"/>
                    <a:pt x="206" y="81"/>
                    <a:pt x="195" y="92"/>
                  </a:cubicBezTo>
                  <a:cubicBezTo>
                    <a:pt x="204" y="91"/>
                    <a:pt x="212" y="91"/>
                    <a:pt x="220" y="93"/>
                  </a:cubicBezTo>
                  <a:cubicBezTo>
                    <a:pt x="227" y="94"/>
                    <a:pt x="239" y="98"/>
                    <a:pt x="254" y="104"/>
                  </a:cubicBezTo>
                  <a:lnTo>
                    <a:pt x="294" y="119"/>
                  </a:lnTo>
                  <a:lnTo>
                    <a:pt x="258" y="145"/>
                  </a:lnTo>
                  <a:lnTo>
                    <a:pt x="213" y="130"/>
                  </a:lnTo>
                  <a:cubicBezTo>
                    <a:pt x="197" y="124"/>
                    <a:pt x="186" y="121"/>
                    <a:pt x="181" y="120"/>
                  </a:cubicBezTo>
                  <a:cubicBezTo>
                    <a:pt x="176" y="119"/>
                    <a:pt x="172" y="119"/>
                    <a:pt x="168" y="120"/>
                  </a:cubicBezTo>
                  <a:cubicBezTo>
                    <a:pt x="164" y="122"/>
                    <a:pt x="158" y="125"/>
                    <a:pt x="152" y="130"/>
                  </a:cubicBezTo>
                  <a:lnTo>
                    <a:pt x="146" y="135"/>
                  </a:lnTo>
                  <a:lnTo>
                    <a:pt x="192" y="196"/>
                  </a:lnTo>
                  <a:lnTo>
                    <a:pt x="162" y="218"/>
                  </a:lnTo>
                  <a:close/>
                  <a:moveTo>
                    <a:pt x="128" y="111"/>
                  </a:moveTo>
                  <a:lnTo>
                    <a:pt x="150" y="95"/>
                  </a:lnTo>
                  <a:cubicBezTo>
                    <a:pt x="164" y="84"/>
                    <a:pt x="172" y="77"/>
                    <a:pt x="175" y="73"/>
                  </a:cubicBezTo>
                  <a:cubicBezTo>
                    <a:pt x="178" y="69"/>
                    <a:pt x="179" y="65"/>
                    <a:pt x="179" y="60"/>
                  </a:cubicBezTo>
                  <a:cubicBezTo>
                    <a:pt x="179" y="56"/>
                    <a:pt x="177" y="52"/>
                    <a:pt x="173" y="47"/>
                  </a:cubicBezTo>
                  <a:cubicBezTo>
                    <a:pt x="170" y="42"/>
                    <a:pt x="165" y="39"/>
                    <a:pt x="161" y="38"/>
                  </a:cubicBezTo>
                  <a:cubicBezTo>
                    <a:pt x="156" y="37"/>
                    <a:pt x="150" y="38"/>
                    <a:pt x="145" y="41"/>
                  </a:cubicBezTo>
                  <a:cubicBezTo>
                    <a:pt x="142" y="42"/>
                    <a:pt x="135" y="48"/>
                    <a:pt x="123" y="57"/>
                  </a:cubicBezTo>
                  <a:lnTo>
                    <a:pt x="100" y="74"/>
                  </a:lnTo>
                  <a:lnTo>
                    <a:pt x="128" y="111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7"/>
            <p:cNvSpPr/>
            <p:nvPr/>
          </p:nvSpPr>
          <p:spPr>
            <a:xfrm>
              <a:off x="1545840" y="1844640"/>
              <a:ext cx="460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100" spc="-1" strike="noStrike">
                  <a:solidFill>
                    <a:srgbClr val="000000"/>
                  </a:solidFill>
                  <a:latin typeface="Arial"/>
                </a:rPr>
                <a:t>β</a:t>
              </a:r>
              <a:r>
                <a:rPr b="1" lang="en-CA" sz="11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7" name="Picture 18" descr="PC3 AMPK total"/>
            <p:cNvPicPr/>
            <p:nvPr/>
          </p:nvPicPr>
          <p:blipFill>
            <a:blip r:embed="rId1"/>
            <a:srcRect l="5255" t="38905" r="6731" b="22432"/>
            <a:stretch/>
          </p:blipFill>
          <p:spPr>
            <a:xfrm>
              <a:off x="2195640" y="1052640"/>
              <a:ext cx="1296720" cy="287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19" descr="PC3 P-AMPK"/>
            <p:cNvPicPr/>
            <p:nvPr/>
          </p:nvPicPr>
          <p:blipFill>
            <a:blip r:embed="rId2">
              <a:lum bright="18000"/>
            </a:blip>
            <a:srcRect l="4852" t="13476" r="0" b="13476"/>
            <a:stretch/>
          </p:blipFill>
          <p:spPr>
            <a:xfrm>
              <a:off x="2195640" y="1413000"/>
              <a:ext cx="1296720" cy="28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20" descr="PC3 actin"/>
            <p:cNvPicPr/>
            <p:nvPr/>
          </p:nvPicPr>
          <p:blipFill>
            <a:blip r:embed="rId3"/>
            <a:srcRect l="0" t="24451" r="0" b="26646"/>
            <a:stretch/>
          </p:blipFill>
          <p:spPr>
            <a:xfrm>
              <a:off x="2195640" y="1773360"/>
              <a:ext cx="1296720" cy="28872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50" name="Picture 4" descr=""/>
          <p:cNvPicPr/>
          <p:nvPr/>
        </p:nvPicPr>
        <p:blipFill>
          <a:blip r:embed="rId4"/>
          <a:stretch/>
        </p:blipFill>
        <p:spPr>
          <a:xfrm>
            <a:off x="971640" y="2708280"/>
            <a:ext cx="3600360" cy="25290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" descr=""/>
          <p:cNvPicPr/>
          <p:nvPr/>
        </p:nvPicPr>
        <p:blipFill>
          <a:blip r:embed="rId5"/>
          <a:stretch/>
        </p:blipFill>
        <p:spPr>
          <a:xfrm>
            <a:off x="6004080" y="260280"/>
            <a:ext cx="1881000" cy="20494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6" descr=""/>
          <p:cNvPicPr/>
          <p:nvPr/>
        </p:nvPicPr>
        <p:blipFill>
          <a:blip r:embed="rId6"/>
          <a:stretch/>
        </p:blipFill>
        <p:spPr>
          <a:xfrm>
            <a:off x="5076720" y="2492280"/>
            <a:ext cx="3888000" cy="2963880"/>
          </a:xfrm>
          <a:prstGeom prst="rect">
            <a:avLst/>
          </a:prstGeom>
          <a:ln w="0">
            <a:noFill/>
          </a:ln>
        </p:spPr>
      </p:pic>
      <p:sp>
        <p:nvSpPr>
          <p:cNvPr id="53" name="Text Box 29"/>
          <p:cNvSpPr/>
          <p:nvPr/>
        </p:nvSpPr>
        <p:spPr>
          <a:xfrm>
            <a:off x="1547640" y="4762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29"/>
          <p:cNvSpPr/>
          <p:nvPr/>
        </p:nvSpPr>
        <p:spPr>
          <a:xfrm>
            <a:off x="1116000" y="24922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29"/>
          <p:cNvSpPr/>
          <p:nvPr/>
        </p:nvSpPr>
        <p:spPr>
          <a:xfrm>
            <a:off x="6219720" y="4762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9"/>
          <p:cNvSpPr/>
          <p:nvPr/>
        </p:nvSpPr>
        <p:spPr>
          <a:xfrm>
            <a:off x="5148360" y="2359080"/>
            <a:ext cx="35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3"/>
          <p:cNvSpPr/>
          <p:nvPr/>
        </p:nvSpPr>
        <p:spPr>
          <a:xfrm>
            <a:off x="10800" y="0"/>
            <a:ext cx="1573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Supplement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Fig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3079440" y="-27000"/>
            <a:ext cx="3390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 u="sng">
                <a:solidFill>
                  <a:srgbClr val="000000"/>
                </a:solidFill>
                <a:uFillTx/>
                <a:latin typeface="Arial"/>
              </a:rPr>
              <a:t>PC3 prostate cancer xenograf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"/>
          <p:cNvSpPr/>
          <p:nvPr/>
        </p:nvSpPr>
        <p:spPr>
          <a:xfrm>
            <a:off x="179280" y="5427720"/>
            <a:ext cx="885672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anchorCtr="1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The effects of ionizing radiation on PC3 prostate cancer xenografts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3 cells were grafted into the flanks of balb/c nude mice and were treated with or without a single fraction of 10Gy IR. The average tumour volumes from each group were measured and expressed as the mean and SE of 6 animals per group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Extracted PC3 tumours were lysed and subjected to western blotting with antibodies against the AMPK pathway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Normalized densitometry values of the results from B. (mean ±SE) of 6 animals per groups are shown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Extracted PC3 tumours were lysed and subjected to immunoblotting with antibodies against the Akt-mTOR pathway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Normalized densitometry values of the results from D. (mean ±SE) of 6 animals per groups are show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9T19:37:57Z</dcterms:created>
  <dc:creator>Dr T</dc:creator>
  <dc:description/>
  <dc:language>en-US</dc:language>
  <cp:lastModifiedBy>theos</cp:lastModifiedBy>
  <dcterms:modified xsi:type="dcterms:W3CDTF">2012-01-11T08:24:58Z</dcterms:modified>
  <cp:revision>75</cp:revision>
  <dc:subject/>
  <dc:title>Slide 1</dc:title>
</cp:coreProperties>
</file>